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9" r:id="rId2"/>
  </p:sldMasterIdLst>
  <p:notesMasterIdLst>
    <p:notesMasterId r:id="rId4"/>
  </p:notesMasterIdLst>
  <p:sldIdLst>
    <p:sldId id="1899" r:id="rId3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040"/>
    <a:srgbClr val="011893"/>
    <a:srgbClr val="FF9300"/>
    <a:srgbClr val="FF2F92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E3FDE45-AF77-4B5C-9715-49D594BDF05E}" styleName="淡色スタイル 1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 autoAdjust="0"/>
    <p:restoredTop sz="77279" autoAdjust="0"/>
  </p:normalViewPr>
  <p:slideViewPr>
    <p:cSldViewPr snapToGrid="0">
      <p:cViewPr varScale="1">
        <p:scale>
          <a:sx n="97" d="100"/>
          <a:sy n="97" d="100"/>
        </p:scale>
        <p:origin x="2360" y="200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15752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90C379C3-418D-C942-B3E5-B75409DD7572}" type="doc">
      <dgm:prSet loTypeId="urn:microsoft.com/office/officeart/2005/8/layout/venn1" loCatId="" qsTypeId="urn:microsoft.com/office/officeart/2005/8/quickstyle/simple1" qsCatId="simple" csTypeId="urn:microsoft.com/office/officeart/2005/8/colors/accent1_2" csCatId="accent1" phldr="1"/>
      <dgm:spPr/>
    </dgm:pt>
    <dgm:pt modelId="{5A2A4AE6-7138-D849-A37D-11E3A9667839}">
      <dgm:prSet phldrT="[テキスト]" custT="1"/>
      <dgm:spPr>
        <a:solidFill>
          <a:schemeClr val="accent3">
            <a:alpha val="34000"/>
          </a:schemeClr>
        </a:solidFill>
        <a:ln>
          <a:solidFill>
            <a:schemeClr val="bg2">
              <a:lumMod val="10000"/>
            </a:schemeClr>
          </a:solidFill>
        </a:ln>
      </dgm:spPr>
      <dgm:t>
        <a:bodyPr/>
        <a:lstStyle/>
        <a:p>
          <a:r>
            <a:rPr kumimoji="1" lang="en-US" altLang="ja-JP" sz="2400" u="sng" dirty="0">
              <a:latin typeface="+mj-ea"/>
              <a:ea typeface="+mj-ea"/>
            </a:rPr>
            <a:t> </a:t>
          </a:r>
          <a:endParaRPr kumimoji="1" lang="ja-JP" altLang="en-US" sz="2400" u="sng" dirty="0">
            <a:latin typeface="+mj-ea"/>
            <a:ea typeface="+mj-ea"/>
          </a:endParaRPr>
        </a:p>
      </dgm:t>
    </dgm:pt>
    <dgm:pt modelId="{9CCE6850-A7A3-2349-9F0C-7436EBC8F6E8}" type="parTrans" cxnId="{CA834DC9-EFEA-1F45-A3C5-9C4C868FBB71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01FA20B4-4793-7E44-829E-65B9F5136C28}" type="sibTrans" cxnId="{CA834DC9-EFEA-1F45-A3C5-9C4C868FBB71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9C961861-5178-234A-8109-292BB4791B98}">
      <dgm:prSet phldrT="[テキスト]" custT="1"/>
      <dgm:spPr>
        <a:solidFill>
          <a:schemeClr val="accent6">
            <a:alpha val="40000"/>
          </a:schemeClr>
        </a:solidFill>
        <a:ln>
          <a:solidFill>
            <a:srgbClr val="FF0000"/>
          </a:solidFill>
        </a:ln>
      </dgm:spPr>
      <dgm:t>
        <a:bodyPr/>
        <a:lstStyle/>
        <a:p>
          <a:endParaRPr kumimoji="1" lang="ja-JP" altLang="en-US" sz="2400" u="sng" dirty="0">
            <a:latin typeface="+mj-ea"/>
            <a:ea typeface="+mj-ea"/>
          </a:endParaRPr>
        </a:p>
      </dgm:t>
    </dgm:pt>
    <dgm:pt modelId="{92E40884-0A86-2743-B963-8DE825904D74}" type="sibTrans" cxnId="{353737E7-A1FF-4C45-916F-C3C4A4BDB7A9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D2BE0B71-6C67-764A-85E2-660824B9B74A}" type="parTrans" cxnId="{353737E7-A1FF-4C45-916F-C3C4A4BDB7A9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F65766A8-C674-8341-85FF-9BBF9A632A6E}">
      <dgm:prSet phldrT="[テキスト]" custT="1"/>
      <dgm:spPr>
        <a:solidFill>
          <a:schemeClr val="accent5">
            <a:lumMod val="40000"/>
            <a:lumOff val="60000"/>
            <a:alpha val="50000"/>
          </a:schemeClr>
        </a:solidFill>
        <a:ln>
          <a:solidFill>
            <a:schemeClr val="tx2"/>
          </a:solidFill>
        </a:ln>
      </dgm:spPr>
      <dgm:t>
        <a:bodyPr/>
        <a:lstStyle/>
        <a:p>
          <a:endParaRPr kumimoji="1" lang="ja-JP" altLang="en-US" sz="2000" u="sng" dirty="0">
            <a:latin typeface="+mj-ea"/>
            <a:ea typeface="+mj-ea"/>
          </a:endParaRPr>
        </a:p>
      </dgm:t>
    </dgm:pt>
    <dgm:pt modelId="{731E129A-1D59-4945-B597-D884207A3F98}" type="sibTrans" cxnId="{7FE4E842-8189-4240-8320-1A65783EBC67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FE2C6BE5-E502-FF46-89A9-DE97B4E236CF}" type="parTrans" cxnId="{7FE4E842-8189-4240-8320-1A65783EBC67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9E9F5959-4CA5-134A-A6C1-73F9FC83DEB7}" type="pres">
      <dgm:prSet presAssocID="{90C379C3-418D-C942-B3E5-B75409DD7572}" presName="compositeShape" presStyleCnt="0">
        <dgm:presLayoutVars>
          <dgm:chMax val="7"/>
          <dgm:dir/>
          <dgm:resizeHandles val="exact"/>
        </dgm:presLayoutVars>
      </dgm:prSet>
      <dgm:spPr/>
    </dgm:pt>
    <dgm:pt modelId="{5369BE29-498E-4642-B4AD-FDD4DC06304E}" type="pres">
      <dgm:prSet presAssocID="{F65766A8-C674-8341-85FF-9BBF9A632A6E}" presName="circ1" presStyleLbl="vennNode1" presStyleIdx="0" presStyleCnt="3" custScaleX="104093" custScaleY="104093" custLinFactNeighborX="-2442" custLinFactNeighborY="19800"/>
      <dgm:spPr/>
    </dgm:pt>
    <dgm:pt modelId="{CD707038-EED4-F64B-853D-FD9F2D683DEB}" type="pres">
      <dgm:prSet presAssocID="{F65766A8-C674-8341-85FF-9BBF9A632A6E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4E54D3F4-E987-0247-A254-2D1077AB17BE}" type="pres">
      <dgm:prSet presAssocID="{5A2A4AE6-7138-D849-A37D-11E3A9667839}" presName="circ2" presStyleLbl="vennNode1" presStyleIdx="1" presStyleCnt="3" custScaleX="111528" custScaleY="111528" custLinFactNeighborX="-20976" custLinFactNeighborY="-16951"/>
      <dgm:spPr/>
    </dgm:pt>
    <dgm:pt modelId="{0602E208-42E0-5D44-902E-DBEF7EA72361}" type="pres">
      <dgm:prSet presAssocID="{5A2A4AE6-7138-D849-A37D-11E3A9667839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1AF8F770-97BB-804B-9B7E-5E72F0A88B63}" type="pres">
      <dgm:prSet presAssocID="{9C961861-5178-234A-8109-292BB4791B98}" presName="circ3" presStyleLbl="vennNode1" presStyleIdx="2" presStyleCnt="3" custScaleX="108554" custScaleY="108554" custLinFactNeighborX="15243" custLinFactNeighborY="-15632"/>
      <dgm:spPr/>
    </dgm:pt>
    <dgm:pt modelId="{CE31E348-9261-3D41-A0F4-65557AACE614}" type="pres">
      <dgm:prSet presAssocID="{9C961861-5178-234A-8109-292BB4791B98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BC072D19-EA1C-C647-BBAD-04CD65D04F74}" type="presOf" srcId="{5A2A4AE6-7138-D849-A37D-11E3A9667839}" destId="{4E54D3F4-E987-0247-A254-2D1077AB17BE}" srcOrd="0" destOrd="0" presId="urn:microsoft.com/office/officeart/2005/8/layout/venn1"/>
    <dgm:cxn modelId="{E459623D-1B34-6145-9D3E-B3BE28905F57}" type="presOf" srcId="{90C379C3-418D-C942-B3E5-B75409DD7572}" destId="{9E9F5959-4CA5-134A-A6C1-73F9FC83DEB7}" srcOrd="0" destOrd="0" presId="urn:microsoft.com/office/officeart/2005/8/layout/venn1"/>
    <dgm:cxn modelId="{7FE4E842-8189-4240-8320-1A65783EBC67}" srcId="{90C379C3-418D-C942-B3E5-B75409DD7572}" destId="{F65766A8-C674-8341-85FF-9BBF9A632A6E}" srcOrd="0" destOrd="0" parTransId="{FE2C6BE5-E502-FF46-89A9-DE97B4E236CF}" sibTransId="{731E129A-1D59-4945-B597-D884207A3F98}"/>
    <dgm:cxn modelId="{F7842445-CA3A-A341-BFD0-A4407D670F1E}" type="presOf" srcId="{9C961861-5178-234A-8109-292BB4791B98}" destId="{CE31E348-9261-3D41-A0F4-65557AACE614}" srcOrd="1" destOrd="0" presId="urn:microsoft.com/office/officeart/2005/8/layout/venn1"/>
    <dgm:cxn modelId="{EC606255-A757-A142-B5C6-C82EF23A53DC}" type="presOf" srcId="{5A2A4AE6-7138-D849-A37D-11E3A9667839}" destId="{0602E208-42E0-5D44-902E-DBEF7EA72361}" srcOrd="1" destOrd="0" presId="urn:microsoft.com/office/officeart/2005/8/layout/venn1"/>
    <dgm:cxn modelId="{A648116D-DF07-5348-9C80-805108F36D45}" type="presOf" srcId="{F65766A8-C674-8341-85FF-9BBF9A632A6E}" destId="{CD707038-EED4-F64B-853D-FD9F2D683DEB}" srcOrd="1" destOrd="0" presId="urn:microsoft.com/office/officeart/2005/8/layout/venn1"/>
    <dgm:cxn modelId="{CA834DC9-EFEA-1F45-A3C5-9C4C868FBB71}" srcId="{90C379C3-418D-C942-B3E5-B75409DD7572}" destId="{5A2A4AE6-7138-D849-A37D-11E3A9667839}" srcOrd="1" destOrd="0" parTransId="{9CCE6850-A7A3-2349-9F0C-7436EBC8F6E8}" sibTransId="{01FA20B4-4793-7E44-829E-65B9F5136C28}"/>
    <dgm:cxn modelId="{2BA7F5D0-D5F2-2B42-8209-4E669D2BA9CF}" type="presOf" srcId="{9C961861-5178-234A-8109-292BB4791B98}" destId="{1AF8F770-97BB-804B-9B7E-5E72F0A88B63}" srcOrd="0" destOrd="0" presId="urn:microsoft.com/office/officeart/2005/8/layout/venn1"/>
    <dgm:cxn modelId="{8411E0DF-F11E-9E4C-ABFF-8A0340EF8D8F}" type="presOf" srcId="{F65766A8-C674-8341-85FF-9BBF9A632A6E}" destId="{5369BE29-498E-4642-B4AD-FDD4DC06304E}" srcOrd="0" destOrd="0" presId="urn:microsoft.com/office/officeart/2005/8/layout/venn1"/>
    <dgm:cxn modelId="{353737E7-A1FF-4C45-916F-C3C4A4BDB7A9}" srcId="{90C379C3-418D-C942-B3E5-B75409DD7572}" destId="{9C961861-5178-234A-8109-292BB4791B98}" srcOrd="2" destOrd="0" parTransId="{D2BE0B71-6C67-764A-85E2-660824B9B74A}" sibTransId="{92E40884-0A86-2743-B963-8DE825904D74}"/>
    <dgm:cxn modelId="{8504F213-8CC2-1648-88B9-B2880EFD1854}" type="presParOf" srcId="{9E9F5959-4CA5-134A-A6C1-73F9FC83DEB7}" destId="{5369BE29-498E-4642-B4AD-FDD4DC06304E}" srcOrd="0" destOrd="0" presId="urn:microsoft.com/office/officeart/2005/8/layout/venn1"/>
    <dgm:cxn modelId="{11C7B972-6AA2-8A4F-858E-E0C1B10A0334}" type="presParOf" srcId="{9E9F5959-4CA5-134A-A6C1-73F9FC83DEB7}" destId="{CD707038-EED4-F64B-853D-FD9F2D683DEB}" srcOrd="1" destOrd="0" presId="urn:microsoft.com/office/officeart/2005/8/layout/venn1"/>
    <dgm:cxn modelId="{FF026E1C-B2B6-DE47-91C5-7A60A4E43C8D}" type="presParOf" srcId="{9E9F5959-4CA5-134A-A6C1-73F9FC83DEB7}" destId="{4E54D3F4-E987-0247-A254-2D1077AB17BE}" srcOrd="2" destOrd="0" presId="urn:microsoft.com/office/officeart/2005/8/layout/venn1"/>
    <dgm:cxn modelId="{EAF635D3-D46E-4544-9576-CF198BCBF41B}" type="presParOf" srcId="{9E9F5959-4CA5-134A-A6C1-73F9FC83DEB7}" destId="{0602E208-42E0-5D44-902E-DBEF7EA72361}" srcOrd="3" destOrd="0" presId="urn:microsoft.com/office/officeart/2005/8/layout/venn1"/>
    <dgm:cxn modelId="{676C5427-051C-0F44-BDFD-AA760AA4CA5E}" type="presParOf" srcId="{9E9F5959-4CA5-134A-A6C1-73F9FC83DEB7}" destId="{1AF8F770-97BB-804B-9B7E-5E72F0A88B63}" srcOrd="4" destOrd="0" presId="urn:microsoft.com/office/officeart/2005/8/layout/venn1"/>
    <dgm:cxn modelId="{C2D8FBBD-EA55-BE4F-B07A-7377AA66828E}" type="presParOf" srcId="{9E9F5959-4CA5-134A-A6C1-73F9FC83DEB7}" destId="{CE31E348-9261-3D41-A0F4-65557AACE614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90C379C3-418D-C942-B3E5-B75409DD7572}" type="doc">
      <dgm:prSet loTypeId="urn:microsoft.com/office/officeart/2005/8/layout/venn1" loCatId="" qsTypeId="urn:microsoft.com/office/officeart/2005/8/quickstyle/simple1" qsCatId="simple" csTypeId="urn:microsoft.com/office/officeart/2005/8/colors/accent1_2" csCatId="accent1" phldr="1"/>
      <dgm:spPr/>
    </dgm:pt>
    <dgm:pt modelId="{5A2A4AE6-7138-D849-A37D-11E3A9667839}">
      <dgm:prSet phldrT="[テキスト]" custT="1"/>
      <dgm:spPr>
        <a:solidFill>
          <a:schemeClr val="accent3">
            <a:alpha val="34000"/>
          </a:schemeClr>
        </a:solidFill>
        <a:ln>
          <a:solidFill>
            <a:schemeClr val="bg2">
              <a:lumMod val="10000"/>
            </a:schemeClr>
          </a:solidFill>
        </a:ln>
      </dgm:spPr>
      <dgm:t>
        <a:bodyPr/>
        <a:lstStyle/>
        <a:p>
          <a:r>
            <a:rPr kumimoji="1" lang="en-US" altLang="ja-JP" sz="2400" u="sng" dirty="0">
              <a:latin typeface="+mj-ea"/>
              <a:ea typeface="+mj-ea"/>
            </a:rPr>
            <a:t> </a:t>
          </a:r>
          <a:endParaRPr kumimoji="1" lang="ja-JP" altLang="en-US" sz="2400" u="sng" dirty="0">
            <a:latin typeface="+mj-ea"/>
            <a:ea typeface="+mj-ea"/>
          </a:endParaRPr>
        </a:p>
      </dgm:t>
    </dgm:pt>
    <dgm:pt modelId="{9CCE6850-A7A3-2349-9F0C-7436EBC8F6E8}" type="parTrans" cxnId="{CA834DC9-EFEA-1F45-A3C5-9C4C868FBB71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01FA20B4-4793-7E44-829E-65B9F5136C28}" type="sibTrans" cxnId="{CA834DC9-EFEA-1F45-A3C5-9C4C868FBB71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9C961861-5178-234A-8109-292BB4791B98}">
      <dgm:prSet phldrT="[テキスト]" custT="1"/>
      <dgm:spPr>
        <a:noFill/>
        <a:ln>
          <a:noFill/>
        </a:ln>
      </dgm:spPr>
      <dgm:t>
        <a:bodyPr/>
        <a:lstStyle/>
        <a:p>
          <a:endParaRPr kumimoji="1" lang="ja-JP" altLang="en-US" sz="2400" u="sng" dirty="0">
            <a:latin typeface="+mj-ea"/>
            <a:ea typeface="+mj-ea"/>
          </a:endParaRPr>
        </a:p>
      </dgm:t>
    </dgm:pt>
    <dgm:pt modelId="{92E40884-0A86-2743-B963-8DE825904D74}" type="sibTrans" cxnId="{353737E7-A1FF-4C45-916F-C3C4A4BDB7A9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D2BE0B71-6C67-764A-85E2-660824B9B74A}" type="parTrans" cxnId="{353737E7-A1FF-4C45-916F-C3C4A4BDB7A9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F65766A8-C674-8341-85FF-9BBF9A632A6E}">
      <dgm:prSet phldrT="[テキスト]" custT="1"/>
      <dgm:spPr>
        <a:solidFill>
          <a:schemeClr val="accent5">
            <a:lumMod val="40000"/>
            <a:lumOff val="60000"/>
            <a:alpha val="50000"/>
          </a:schemeClr>
        </a:solidFill>
        <a:ln>
          <a:solidFill>
            <a:schemeClr val="tx2"/>
          </a:solidFill>
        </a:ln>
      </dgm:spPr>
      <dgm:t>
        <a:bodyPr/>
        <a:lstStyle/>
        <a:p>
          <a:endParaRPr kumimoji="1" lang="ja-JP" altLang="en-US" sz="2000" u="sng" dirty="0">
            <a:latin typeface="+mj-ea"/>
            <a:ea typeface="+mj-ea"/>
          </a:endParaRPr>
        </a:p>
      </dgm:t>
    </dgm:pt>
    <dgm:pt modelId="{731E129A-1D59-4945-B597-D884207A3F98}" type="sibTrans" cxnId="{7FE4E842-8189-4240-8320-1A65783EBC67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FE2C6BE5-E502-FF46-89A9-DE97B4E236CF}" type="parTrans" cxnId="{7FE4E842-8189-4240-8320-1A65783EBC67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9E9F5959-4CA5-134A-A6C1-73F9FC83DEB7}" type="pres">
      <dgm:prSet presAssocID="{90C379C3-418D-C942-B3E5-B75409DD7572}" presName="compositeShape" presStyleCnt="0">
        <dgm:presLayoutVars>
          <dgm:chMax val="7"/>
          <dgm:dir/>
          <dgm:resizeHandles val="exact"/>
        </dgm:presLayoutVars>
      </dgm:prSet>
      <dgm:spPr/>
    </dgm:pt>
    <dgm:pt modelId="{5369BE29-498E-4642-B4AD-FDD4DC06304E}" type="pres">
      <dgm:prSet presAssocID="{F65766A8-C674-8341-85FF-9BBF9A632A6E}" presName="circ1" presStyleLbl="vennNode1" presStyleIdx="0" presStyleCnt="3" custScaleX="104093" custScaleY="104093" custLinFactNeighborX="-2442" custLinFactNeighborY="19800"/>
      <dgm:spPr/>
    </dgm:pt>
    <dgm:pt modelId="{CD707038-EED4-F64B-853D-FD9F2D683DEB}" type="pres">
      <dgm:prSet presAssocID="{F65766A8-C674-8341-85FF-9BBF9A632A6E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4E54D3F4-E987-0247-A254-2D1077AB17BE}" type="pres">
      <dgm:prSet presAssocID="{5A2A4AE6-7138-D849-A37D-11E3A9667839}" presName="circ2" presStyleLbl="vennNode1" presStyleIdx="1" presStyleCnt="3" custScaleX="111528" custScaleY="111528" custLinFactNeighborX="-20429" custLinFactNeighborY="-16951"/>
      <dgm:spPr/>
    </dgm:pt>
    <dgm:pt modelId="{0602E208-42E0-5D44-902E-DBEF7EA72361}" type="pres">
      <dgm:prSet presAssocID="{5A2A4AE6-7138-D849-A37D-11E3A9667839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1AF8F770-97BB-804B-9B7E-5E72F0A88B63}" type="pres">
      <dgm:prSet presAssocID="{9C961861-5178-234A-8109-292BB4791B98}" presName="circ3" presStyleLbl="vennNode1" presStyleIdx="2" presStyleCnt="3" custScaleX="108554" custScaleY="108554" custLinFactNeighborX="15790" custLinFactNeighborY="-16179"/>
      <dgm:spPr/>
    </dgm:pt>
    <dgm:pt modelId="{CE31E348-9261-3D41-A0F4-65557AACE614}" type="pres">
      <dgm:prSet presAssocID="{9C961861-5178-234A-8109-292BB4791B98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BC072D19-EA1C-C647-BBAD-04CD65D04F74}" type="presOf" srcId="{5A2A4AE6-7138-D849-A37D-11E3A9667839}" destId="{4E54D3F4-E987-0247-A254-2D1077AB17BE}" srcOrd="0" destOrd="0" presId="urn:microsoft.com/office/officeart/2005/8/layout/venn1"/>
    <dgm:cxn modelId="{E459623D-1B34-6145-9D3E-B3BE28905F57}" type="presOf" srcId="{90C379C3-418D-C942-B3E5-B75409DD7572}" destId="{9E9F5959-4CA5-134A-A6C1-73F9FC83DEB7}" srcOrd="0" destOrd="0" presId="urn:microsoft.com/office/officeart/2005/8/layout/venn1"/>
    <dgm:cxn modelId="{7FE4E842-8189-4240-8320-1A65783EBC67}" srcId="{90C379C3-418D-C942-B3E5-B75409DD7572}" destId="{F65766A8-C674-8341-85FF-9BBF9A632A6E}" srcOrd="0" destOrd="0" parTransId="{FE2C6BE5-E502-FF46-89A9-DE97B4E236CF}" sibTransId="{731E129A-1D59-4945-B597-D884207A3F98}"/>
    <dgm:cxn modelId="{F7842445-CA3A-A341-BFD0-A4407D670F1E}" type="presOf" srcId="{9C961861-5178-234A-8109-292BB4791B98}" destId="{CE31E348-9261-3D41-A0F4-65557AACE614}" srcOrd="1" destOrd="0" presId="urn:microsoft.com/office/officeart/2005/8/layout/venn1"/>
    <dgm:cxn modelId="{EC606255-A757-A142-B5C6-C82EF23A53DC}" type="presOf" srcId="{5A2A4AE6-7138-D849-A37D-11E3A9667839}" destId="{0602E208-42E0-5D44-902E-DBEF7EA72361}" srcOrd="1" destOrd="0" presId="urn:microsoft.com/office/officeart/2005/8/layout/venn1"/>
    <dgm:cxn modelId="{A648116D-DF07-5348-9C80-805108F36D45}" type="presOf" srcId="{F65766A8-C674-8341-85FF-9BBF9A632A6E}" destId="{CD707038-EED4-F64B-853D-FD9F2D683DEB}" srcOrd="1" destOrd="0" presId="urn:microsoft.com/office/officeart/2005/8/layout/venn1"/>
    <dgm:cxn modelId="{CA834DC9-EFEA-1F45-A3C5-9C4C868FBB71}" srcId="{90C379C3-418D-C942-B3E5-B75409DD7572}" destId="{5A2A4AE6-7138-D849-A37D-11E3A9667839}" srcOrd="1" destOrd="0" parTransId="{9CCE6850-A7A3-2349-9F0C-7436EBC8F6E8}" sibTransId="{01FA20B4-4793-7E44-829E-65B9F5136C28}"/>
    <dgm:cxn modelId="{2BA7F5D0-D5F2-2B42-8209-4E669D2BA9CF}" type="presOf" srcId="{9C961861-5178-234A-8109-292BB4791B98}" destId="{1AF8F770-97BB-804B-9B7E-5E72F0A88B63}" srcOrd="0" destOrd="0" presId="urn:microsoft.com/office/officeart/2005/8/layout/venn1"/>
    <dgm:cxn modelId="{8411E0DF-F11E-9E4C-ABFF-8A0340EF8D8F}" type="presOf" srcId="{F65766A8-C674-8341-85FF-9BBF9A632A6E}" destId="{5369BE29-498E-4642-B4AD-FDD4DC06304E}" srcOrd="0" destOrd="0" presId="urn:microsoft.com/office/officeart/2005/8/layout/venn1"/>
    <dgm:cxn modelId="{353737E7-A1FF-4C45-916F-C3C4A4BDB7A9}" srcId="{90C379C3-418D-C942-B3E5-B75409DD7572}" destId="{9C961861-5178-234A-8109-292BB4791B98}" srcOrd="2" destOrd="0" parTransId="{D2BE0B71-6C67-764A-85E2-660824B9B74A}" sibTransId="{92E40884-0A86-2743-B963-8DE825904D74}"/>
    <dgm:cxn modelId="{8504F213-8CC2-1648-88B9-B2880EFD1854}" type="presParOf" srcId="{9E9F5959-4CA5-134A-A6C1-73F9FC83DEB7}" destId="{5369BE29-498E-4642-B4AD-FDD4DC06304E}" srcOrd="0" destOrd="0" presId="urn:microsoft.com/office/officeart/2005/8/layout/venn1"/>
    <dgm:cxn modelId="{11C7B972-6AA2-8A4F-858E-E0C1B10A0334}" type="presParOf" srcId="{9E9F5959-4CA5-134A-A6C1-73F9FC83DEB7}" destId="{CD707038-EED4-F64B-853D-FD9F2D683DEB}" srcOrd="1" destOrd="0" presId="urn:microsoft.com/office/officeart/2005/8/layout/venn1"/>
    <dgm:cxn modelId="{FF026E1C-B2B6-DE47-91C5-7A60A4E43C8D}" type="presParOf" srcId="{9E9F5959-4CA5-134A-A6C1-73F9FC83DEB7}" destId="{4E54D3F4-E987-0247-A254-2D1077AB17BE}" srcOrd="2" destOrd="0" presId="urn:microsoft.com/office/officeart/2005/8/layout/venn1"/>
    <dgm:cxn modelId="{EAF635D3-D46E-4544-9576-CF198BCBF41B}" type="presParOf" srcId="{9E9F5959-4CA5-134A-A6C1-73F9FC83DEB7}" destId="{0602E208-42E0-5D44-902E-DBEF7EA72361}" srcOrd="3" destOrd="0" presId="urn:microsoft.com/office/officeart/2005/8/layout/venn1"/>
    <dgm:cxn modelId="{676C5427-051C-0F44-BDFD-AA760AA4CA5E}" type="presParOf" srcId="{9E9F5959-4CA5-134A-A6C1-73F9FC83DEB7}" destId="{1AF8F770-97BB-804B-9B7E-5E72F0A88B63}" srcOrd="4" destOrd="0" presId="urn:microsoft.com/office/officeart/2005/8/layout/venn1"/>
    <dgm:cxn modelId="{C2D8FBBD-EA55-BE4F-B07A-7377AA66828E}" type="presParOf" srcId="{9E9F5959-4CA5-134A-A6C1-73F9FC83DEB7}" destId="{CE31E348-9261-3D41-A0F4-65557AACE614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12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90C379C3-418D-C942-B3E5-B75409DD7572}" type="doc">
      <dgm:prSet loTypeId="urn:microsoft.com/office/officeart/2005/8/layout/venn1" loCatId="" qsTypeId="urn:microsoft.com/office/officeart/2005/8/quickstyle/simple1" qsCatId="simple" csTypeId="urn:microsoft.com/office/officeart/2005/8/colors/accent1_2" csCatId="accent1" phldr="1"/>
      <dgm:spPr/>
    </dgm:pt>
    <dgm:pt modelId="{9C961861-5178-234A-8109-292BB4791B98}">
      <dgm:prSet phldrT="[テキスト]" custT="1"/>
      <dgm:spPr>
        <a:solidFill>
          <a:schemeClr val="accent6">
            <a:alpha val="40000"/>
          </a:schemeClr>
        </a:solidFill>
        <a:ln>
          <a:solidFill>
            <a:srgbClr val="FF0000"/>
          </a:solidFill>
        </a:ln>
      </dgm:spPr>
      <dgm:t>
        <a:bodyPr/>
        <a:lstStyle/>
        <a:p>
          <a:endParaRPr kumimoji="1" lang="ja-JP" altLang="en-US" sz="2400" u="sng" dirty="0">
            <a:latin typeface="+mj-ea"/>
            <a:ea typeface="+mj-ea"/>
          </a:endParaRPr>
        </a:p>
      </dgm:t>
    </dgm:pt>
    <dgm:pt modelId="{92E40884-0A86-2743-B963-8DE825904D74}" type="sibTrans" cxnId="{353737E7-A1FF-4C45-916F-C3C4A4BDB7A9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D2BE0B71-6C67-764A-85E2-660824B9B74A}" type="parTrans" cxnId="{353737E7-A1FF-4C45-916F-C3C4A4BDB7A9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F65766A8-C674-8341-85FF-9BBF9A632A6E}">
      <dgm:prSet phldrT="[テキスト]" custT="1"/>
      <dgm:spPr>
        <a:solidFill>
          <a:schemeClr val="accent5">
            <a:lumMod val="40000"/>
            <a:lumOff val="60000"/>
            <a:alpha val="50000"/>
          </a:schemeClr>
        </a:solidFill>
        <a:ln>
          <a:solidFill>
            <a:schemeClr val="tx2"/>
          </a:solidFill>
        </a:ln>
      </dgm:spPr>
      <dgm:t>
        <a:bodyPr/>
        <a:lstStyle/>
        <a:p>
          <a:endParaRPr kumimoji="1" lang="ja-JP" altLang="en-US" sz="2000" u="sng" dirty="0">
            <a:latin typeface="+mj-ea"/>
            <a:ea typeface="+mj-ea"/>
          </a:endParaRPr>
        </a:p>
      </dgm:t>
    </dgm:pt>
    <dgm:pt modelId="{731E129A-1D59-4945-B597-D884207A3F98}" type="sibTrans" cxnId="{7FE4E842-8189-4240-8320-1A65783EBC67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FE2C6BE5-E502-FF46-89A9-DE97B4E236CF}" type="parTrans" cxnId="{7FE4E842-8189-4240-8320-1A65783EBC67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5A2A4AE6-7138-D849-A37D-11E3A9667839}">
      <dgm:prSet phldrT="[テキスト]" custT="1"/>
      <dgm:spPr>
        <a:noFill/>
        <a:ln>
          <a:noFill/>
        </a:ln>
      </dgm:spPr>
      <dgm:t>
        <a:bodyPr/>
        <a:lstStyle/>
        <a:p>
          <a:r>
            <a:rPr kumimoji="1" lang="en-US" altLang="ja-JP" sz="2400" u="sng" dirty="0">
              <a:latin typeface="+mj-ea"/>
              <a:ea typeface="+mj-ea"/>
            </a:rPr>
            <a:t> </a:t>
          </a:r>
          <a:endParaRPr kumimoji="1" lang="ja-JP" altLang="en-US" sz="2400" u="sng" dirty="0">
            <a:latin typeface="+mj-ea"/>
            <a:ea typeface="+mj-ea"/>
          </a:endParaRPr>
        </a:p>
      </dgm:t>
    </dgm:pt>
    <dgm:pt modelId="{01FA20B4-4793-7E44-829E-65B9F5136C28}" type="sibTrans" cxnId="{CA834DC9-EFEA-1F45-A3C5-9C4C868FBB71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9CCE6850-A7A3-2349-9F0C-7436EBC8F6E8}" type="parTrans" cxnId="{CA834DC9-EFEA-1F45-A3C5-9C4C868FBB71}">
      <dgm:prSet/>
      <dgm:spPr/>
      <dgm:t>
        <a:bodyPr/>
        <a:lstStyle/>
        <a:p>
          <a:endParaRPr kumimoji="1" lang="ja-JP" altLang="en-US" sz="1200">
            <a:latin typeface="+mj-ea"/>
            <a:ea typeface="+mj-ea"/>
          </a:endParaRPr>
        </a:p>
      </dgm:t>
    </dgm:pt>
    <dgm:pt modelId="{9E9F5959-4CA5-134A-A6C1-73F9FC83DEB7}" type="pres">
      <dgm:prSet presAssocID="{90C379C3-418D-C942-B3E5-B75409DD7572}" presName="compositeShape" presStyleCnt="0">
        <dgm:presLayoutVars>
          <dgm:chMax val="7"/>
          <dgm:dir/>
          <dgm:resizeHandles val="exact"/>
        </dgm:presLayoutVars>
      </dgm:prSet>
      <dgm:spPr/>
    </dgm:pt>
    <dgm:pt modelId="{5369BE29-498E-4642-B4AD-FDD4DC06304E}" type="pres">
      <dgm:prSet presAssocID="{F65766A8-C674-8341-85FF-9BBF9A632A6E}" presName="circ1" presStyleLbl="vennNode1" presStyleIdx="0" presStyleCnt="3" custScaleX="104093" custScaleY="104093" custLinFactNeighborX="-2442" custLinFactNeighborY="19800"/>
      <dgm:spPr/>
    </dgm:pt>
    <dgm:pt modelId="{CD707038-EED4-F64B-853D-FD9F2D683DEB}" type="pres">
      <dgm:prSet presAssocID="{F65766A8-C674-8341-85FF-9BBF9A632A6E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4E54D3F4-E987-0247-A254-2D1077AB17BE}" type="pres">
      <dgm:prSet presAssocID="{5A2A4AE6-7138-D849-A37D-11E3A9667839}" presName="circ2" presStyleLbl="vennNode1" presStyleIdx="1" presStyleCnt="3" custScaleX="111528" custScaleY="111528" custLinFactNeighborX="-21523" custLinFactNeighborY="-17498"/>
      <dgm:spPr/>
    </dgm:pt>
    <dgm:pt modelId="{0602E208-42E0-5D44-902E-DBEF7EA72361}" type="pres">
      <dgm:prSet presAssocID="{5A2A4AE6-7138-D849-A37D-11E3A9667839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1AF8F770-97BB-804B-9B7E-5E72F0A88B63}" type="pres">
      <dgm:prSet presAssocID="{9C961861-5178-234A-8109-292BB4791B98}" presName="circ3" presStyleLbl="vennNode1" presStyleIdx="2" presStyleCnt="3" custScaleX="108554" custScaleY="108554" custLinFactNeighborX="15243" custLinFactNeighborY="-15632"/>
      <dgm:spPr/>
    </dgm:pt>
    <dgm:pt modelId="{CE31E348-9261-3D41-A0F4-65557AACE614}" type="pres">
      <dgm:prSet presAssocID="{9C961861-5178-234A-8109-292BB4791B98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BC072D19-EA1C-C647-BBAD-04CD65D04F74}" type="presOf" srcId="{5A2A4AE6-7138-D849-A37D-11E3A9667839}" destId="{4E54D3F4-E987-0247-A254-2D1077AB17BE}" srcOrd="0" destOrd="0" presId="urn:microsoft.com/office/officeart/2005/8/layout/venn1"/>
    <dgm:cxn modelId="{E459623D-1B34-6145-9D3E-B3BE28905F57}" type="presOf" srcId="{90C379C3-418D-C942-B3E5-B75409DD7572}" destId="{9E9F5959-4CA5-134A-A6C1-73F9FC83DEB7}" srcOrd="0" destOrd="0" presId="urn:microsoft.com/office/officeart/2005/8/layout/venn1"/>
    <dgm:cxn modelId="{7FE4E842-8189-4240-8320-1A65783EBC67}" srcId="{90C379C3-418D-C942-B3E5-B75409DD7572}" destId="{F65766A8-C674-8341-85FF-9BBF9A632A6E}" srcOrd="0" destOrd="0" parTransId="{FE2C6BE5-E502-FF46-89A9-DE97B4E236CF}" sibTransId="{731E129A-1D59-4945-B597-D884207A3F98}"/>
    <dgm:cxn modelId="{F7842445-CA3A-A341-BFD0-A4407D670F1E}" type="presOf" srcId="{9C961861-5178-234A-8109-292BB4791B98}" destId="{CE31E348-9261-3D41-A0F4-65557AACE614}" srcOrd="1" destOrd="0" presId="urn:microsoft.com/office/officeart/2005/8/layout/venn1"/>
    <dgm:cxn modelId="{EC606255-A757-A142-B5C6-C82EF23A53DC}" type="presOf" srcId="{5A2A4AE6-7138-D849-A37D-11E3A9667839}" destId="{0602E208-42E0-5D44-902E-DBEF7EA72361}" srcOrd="1" destOrd="0" presId="urn:microsoft.com/office/officeart/2005/8/layout/venn1"/>
    <dgm:cxn modelId="{A648116D-DF07-5348-9C80-805108F36D45}" type="presOf" srcId="{F65766A8-C674-8341-85FF-9BBF9A632A6E}" destId="{CD707038-EED4-F64B-853D-FD9F2D683DEB}" srcOrd="1" destOrd="0" presId="urn:microsoft.com/office/officeart/2005/8/layout/venn1"/>
    <dgm:cxn modelId="{CA834DC9-EFEA-1F45-A3C5-9C4C868FBB71}" srcId="{90C379C3-418D-C942-B3E5-B75409DD7572}" destId="{5A2A4AE6-7138-D849-A37D-11E3A9667839}" srcOrd="1" destOrd="0" parTransId="{9CCE6850-A7A3-2349-9F0C-7436EBC8F6E8}" sibTransId="{01FA20B4-4793-7E44-829E-65B9F5136C28}"/>
    <dgm:cxn modelId="{2BA7F5D0-D5F2-2B42-8209-4E669D2BA9CF}" type="presOf" srcId="{9C961861-5178-234A-8109-292BB4791B98}" destId="{1AF8F770-97BB-804B-9B7E-5E72F0A88B63}" srcOrd="0" destOrd="0" presId="urn:microsoft.com/office/officeart/2005/8/layout/venn1"/>
    <dgm:cxn modelId="{8411E0DF-F11E-9E4C-ABFF-8A0340EF8D8F}" type="presOf" srcId="{F65766A8-C674-8341-85FF-9BBF9A632A6E}" destId="{5369BE29-498E-4642-B4AD-FDD4DC06304E}" srcOrd="0" destOrd="0" presId="urn:microsoft.com/office/officeart/2005/8/layout/venn1"/>
    <dgm:cxn modelId="{353737E7-A1FF-4C45-916F-C3C4A4BDB7A9}" srcId="{90C379C3-418D-C942-B3E5-B75409DD7572}" destId="{9C961861-5178-234A-8109-292BB4791B98}" srcOrd="2" destOrd="0" parTransId="{D2BE0B71-6C67-764A-85E2-660824B9B74A}" sibTransId="{92E40884-0A86-2743-B963-8DE825904D74}"/>
    <dgm:cxn modelId="{8504F213-8CC2-1648-88B9-B2880EFD1854}" type="presParOf" srcId="{9E9F5959-4CA5-134A-A6C1-73F9FC83DEB7}" destId="{5369BE29-498E-4642-B4AD-FDD4DC06304E}" srcOrd="0" destOrd="0" presId="urn:microsoft.com/office/officeart/2005/8/layout/venn1"/>
    <dgm:cxn modelId="{11C7B972-6AA2-8A4F-858E-E0C1B10A0334}" type="presParOf" srcId="{9E9F5959-4CA5-134A-A6C1-73F9FC83DEB7}" destId="{CD707038-EED4-F64B-853D-FD9F2D683DEB}" srcOrd="1" destOrd="0" presId="urn:microsoft.com/office/officeart/2005/8/layout/venn1"/>
    <dgm:cxn modelId="{FF026E1C-B2B6-DE47-91C5-7A60A4E43C8D}" type="presParOf" srcId="{9E9F5959-4CA5-134A-A6C1-73F9FC83DEB7}" destId="{4E54D3F4-E987-0247-A254-2D1077AB17BE}" srcOrd="2" destOrd="0" presId="urn:microsoft.com/office/officeart/2005/8/layout/venn1"/>
    <dgm:cxn modelId="{EAF635D3-D46E-4544-9576-CF198BCBF41B}" type="presParOf" srcId="{9E9F5959-4CA5-134A-A6C1-73F9FC83DEB7}" destId="{0602E208-42E0-5D44-902E-DBEF7EA72361}" srcOrd="3" destOrd="0" presId="urn:microsoft.com/office/officeart/2005/8/layout/venn1"/>
    <dgm:cxn modelId="{676C5427-051C-0F44-BDFD-AA760AA4CA5E}" type="presParOf" srcId="{9E9F5959-4CA5-134A-A6C1-73F9FC83DEB7}" destId="{1AF8F770-97BB-804B-9B7E-5E72F0A88B63}" srcOrd="4" destOrd="0" presId="urn:microsoft.com/office/officeart/2005/8/layout/venn1"/>
    <dgm:cxn modelId="{C2D8FBBD-EA55-BE4F-B07A-7377AA66828E}" type="presParOf" srcId="{9E9F5959-4CA5-134A-A6C1-73F9FC83DEB7}" destId="{CE31E348-9261-3D41-A0F4-65557AACE614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1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69BE29-498E-4642-B4AD-FDD4DC06304E}">
      <dsp:nvSpPr>
        <dsp:cNvPr id="0" name=""/>
        <dsp:cNvSpPr/>
      </dsp:nvSpPr>
      <dsp:spPr>
        <a:xfrm>
          <a:off x="1189419" y="435233"/>
          <a:ext cx="2520000" cy="2520000"/>
        </a:xfrm>
        <a:prstGeom prst="ellipse">
          <a:avLst/>
        </a:prstGeom>
        <a:solidFill>
          <a:schemeClr val="accent5">
            <a:lumMod val="40000"/>
            <a:lumOff val="60000"/>
            <a:alpha val="50000"/>
          </a:schemeClr>
        </a:solidFill>
        <a:ln w="25400" cap="flat" cmpd="sng" algn="ctr">
          <a:solidFill>
            <a:schemeClr val="tx2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000" u="sng" kern="1200" dirty="0">
            <a:latin typeface="+mj-ea"/>
            <a:ea typeface="+mj-ea"/>
          </a:endParaRPr>
        </a:p>
      </dsp:txBody>
      <dsp:txXfrm>
        <a:off x="1525419" y="876233"/>
        <a:ext cx="1848000" cy="1134000"/>
      </dsp:txXfrm>
    </dsp:sp>
    <dsp:sp modelId="{4E54D3F4-E987-0247-A254-2D1077AB17BE}">
      <dsp:nvSpPr>
        <dsp:cNvPr id="0" name=""/>
        <dsp:cNvSpPr/>
      </dsp:nvSpPr>
      <dsp:spPr>
        <a:xfrm>
          <a:off x="1524275" y="968596"/>
          <a:ext cx="2699995" cy="2699995"/>
        </a:xfrm>
        <a:prstGeom prst="ellipse">
          <a:avLst/>
        </a:prstGeom>
        <a:solidFill>
          <a:schemeClr val="accent3">
            <a:alpha val="34000"/>
          </a:schemeClr>
        </a:solidFill>
        <a:ln w="25400" cap="flat" cmpd="sng" algn="ctr">
          <a:solidFill>
            <a:schemeClr val="bg2">
              <a:lumMod val="1000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2400" u="sng" kern="1200" dirty="0">
              <a:latin typeface="+mj-ea"/>
              <a:ea typeface="+mj-ea"/>
            </a:rPr>
            <a:t> </a:t>
          </a:r>
          <a:endParaRPr kumimoji="1" lang="ja-JP" altLang="en-US" sz="2400" u="sng" kern="1200" dirty="0">
            <a:latin typeface="+mj-ea"/>
            <a:ea typeface="+mj-ea"/>
          </a:endParaRPr>
        </a:p>
      </dsp:txBody>
      <dsp:txXfrm>
        <a:off x="2350024" y="1666095"/>
        <a:ext cx="1619997" cy="1484997"/>
      </dsp:txXfrm>
    </dsp:sp>
    <dsp:sp modelId="{1AF8F770-97BB-804B-9B7E-5E72F0A88B63}">
      <dsp:nvSpPr>
        <dsp:cNvPr id="0" name=""/>
        <dsp:cNvSpPr/>
      </dsp:nvSpPr>
      <dsp:spPr>
        <a:xfrm>
          <a:off x="690013" y="1036527"/>
          <a:ext cx="2627997" cy="2627997"/>
        </a:xfrm>
        <a:prstGeom prst="ellipse">
          <a:avLst/>
        </a:prstGeom>
        <a:solidFill>
          <a:schemeClr val="accent6">
            <a:alpha val="40000"/>
          </a:schemeClr>
        </a:solidFill>
        <a:ln w="25400" cap="flat" cmpd="sng" algn="ctr">
          <a:solidFill>
            <a:srgbClr val="FF000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400" u="sng" kern="1200" dirty="0">
            <a:latin typeface="+mj-ea"/>
            <a:ea typeface="+mj-ea"/>
          </a:endParaRPr>
        </a:p>
      </dsp:txBody>
      <dsp:txXfrm>
        <a:off x="937482" y="1715427"/>
        <a:ext cx="1576798" cy="1445398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69BE29-498E-4642-B4AD-FDD4DC06304E}">
      <dsp:nvSpPr>
        <dsp:cNvPr id="0" name=""/>
        <dsp:cNvSpPr/>
      </dsp:nvSpPr>
      <dsp:spPr>
        <a:xfrm>
          <a:off x="1189419" y="435233"/>
          <a:ext cx="2520000" cy="2520000"/>
        </a:xfrm>
        <a:prstGeom prst="ellipse">
          <a:avLst/>
        </a:prstGeom>
        <a:solidFill>
          <a:schemeClr val="accent5">
            <a:lumMod val="40000"/>
            <a:lumOff val="60000"/>
            <a:alpha val="50000"/>
          </a:schemeClr>
        </a:solidFill>
        <a:ln w="25400" cap="flat" cmpd="sng" algn="ctr">
          <a:solidFill>
            <a:schemeClr val="tx2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000" u="sng" kern="1200" dirty="0">
            <a:latin typeface="+mj-ea"/>
            <a:ea typeface="+mj-ea"/>
          </a:endParaRPr>
        </a:p>
      </dsp:txBody>
      <dsp:txXfrm>
        <a:off x="1525419" y="876233"/>
        <a:ext cx="1848000" cy="1134000"/>
      </dsp:txXfrm>
    </dsp:sp>
    <dsp:sp modelId="{4E54D3F4-E987-0247-A254-2D1077AB17BE}">
      <dsp:nvSpPr>
        <dsp:cNvPr id="0" name=""/>
        <dsp:cNvSpPr/>
      </dsp:nvSpPr>
      <dsp:spPr>
        <a:xfrm>
          <a:off x="1537518" y="968596"/>
          <a:ext cx="2699995" cy="2699995"/>
        </a:xfrm>
        <a:prstGeom prst="ellipse">
          <a:avLst/>
        </a:prstGeom>
        <a:solidFill>
          <a:schemeClr val="accent3">
            <a:alpha val="34000"/>
          </a:schemeClr>
        </a:solidFill>
        <a:ln w="25400" cap="flat" cmpd="sng" algn="ctr">
          <a:solidFill>
            <a:schemeClr val="bg2">
              <a:lumMod val="1000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2400" u="sng" kern="1200" dirty="0">
              <a:latin typeface="+mj-ea"/>
              <a:ea typeface="+mj-ea"/>
            </a:rPr>
            <a:t> </a:t>
          </a:r>
          <a:endParaRPr kumimoji="1" lang="ja-JP" altLang="en-US" sz="2400" u="sng" kern="1200" dirty="0">
            <a:latin typeface="+mj-ea"/>
            <a:ea typeface="+mj-ea"/>
          </a:endParaRPr>
        </a:p>
      </dsp:txBody>
      <dsp:txXfrm>
        <a:off x="2363266" y="1666095"/>
        <a:ext cx="1619997" cy="1484997"/>
      </dsp:txXfrm>
    </dsp:sp>
    <dsp:sp modelId="{1AF8F770-97BB-804B-9B7E-5E72F0A88B63}">
      <dsp:nvSpPr>
        <dsp:cNvPr id="0" name=""/>
        <dsp:cNvSpPr/>
      </dsp:nvSpPr>
      <dsp:spPr>
        <a:xfrm>
          <a:off x="703255" y="1023285"/>
          <a:ext cx="2627997" cy="2627997"/>
        </a:xfrm>
        <a:prstGeom prst="ellipse">
          <a:avLst/>
        </a:prstGeom>
        <a:noFill/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400" u="sng" kern="1200" dirty="0">
            <a:latin typeface="+mj-ea"/>
            <a:ea typeface="+mj-ea"/>
          </a:endParaRPr>
        </a:p>
      </dsp:txBody>
      <dsp:txXfrm>
        <a:off x="950725" y="1702184"/>
        <a:ext cx="1576798" cy="1445398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69BE29-498E-4642-B4AD-FDD4DC06304E}">
      <dsp:nvSpPr>
        <dsp:cNvPr id="0" name=""/>
        <dsp:cNvSpPr/>
      </dsp:nvSpPr>
      <dsp:spPr>
        <a:xfrm>
          <a:off x="1189419" y="435233"/>
          <a:ext cx="2520000" cy="2520000"/>
        </a:xfrm>
        <a:prstGeom prst="ellipse">
          <a:avLst/>
        </a:prstGeom>
        <a:solidFill>
          <a:schemeClr val="accent5">
            <a:lumMod val="40000"/>
            <a:lumOff val="60000"/>
            <a:alpha val="50000"/>
          </a:schemeClr>
        </a:solidFill>
        <a:ln w="25400" cap="flat" cmpd="sng" algn="ctr">
          <a:solidFill>
            <a:schemeClr val="tx2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000" u="sng" kern="1200" dirty="0">
            <a:latin typeface="+mj-ea"/>
            <a:ea typeface="+mj-ea"/>
          </a:endParaRPr>
        </a:p>
      </dsp:txBody>
      <dsp:txXfrm>
        <a:off x="1525419" y="876233"/>
        <a:ext cx="1848000" cy="1134000"/>
      </dsp:txXfrm>
    </dsp:sp>
    <dsp:sp modelId="{4E54D3F4-E987-0247-A254-2D1077AB17BE}">
      <dsp:nvSpPr>
        <dsp:cNvPr id="0" name=""/>
        <dsp:cNvSpPr/>
      </dsp:nvSpPr>
      <dsp:spPr>
        <a:xfrm>
          <a:off x="1511033" y="955354"/>
          <a:ext cx="2699995" cy="2699995"/>
        </a:xfrm>
        <a:prstGeom prst="ellipse">
          <a:avLst/>
        </a:prstGeom>
        <a:noFill/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2400" u="sng" kern="1200" dirty="0">
              <a:latin typeface="+mj-ea"/>
              <a:ea typeface="+mj-ea"/>
            </a:rPr>
            <a:t> </a:t>
          </a:r>
          <a:endParaRPr kumimoji="1" lang="ja-JP" altLang="en-US" sz="2400" u="sng" kern="1200" dirty="0">
            <a:latin typeface="+mj-ea"/>
            <a:ea typeface="+mj-ea"/>
          </a:endParaRPr>
        </a:p>
      </dsp:txBody>
      <dsp:txXfrm>
        <a:off x="2336781" y="1652853"/>
        <a:ext cx="1619997" cy="1484997"/>
      </dsp:txXfrm>
    </dsp:sp>
    <dsp:sp modelId="{1AF8F770-97BB-804B-9B7E-5E72F0A88B63}">
      <dsp:nvSpPr>
        <dsp:cNvPr id="0" name=""/>
        <dsp:cNvSpPr/>
      </dsp:nvSpPr>
      <dsp:spPr>
        <a:xfrm>
          <a:off x="690013" y="1036527"/>
          <a:ext cx="2627997" cy="2627997"/>
        </a:xfrm>
        <a:prstGeom prst="ellipse">
          <a:avLst/>
        </a:prstGeom>
        <a:solidFill>
          <a:schemeClr val="accent6">
            <a:alpha val="40000"/>
          </a:schemeClr>
        </a:solidFill>
        <a:ln w="25400" cap="flat" cmpd="sng" algn="ctr">
          <a:solidFill>
            <a:srgbClr val="FF000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400" u="sng" kern="1200" dirty="0">
            <a:latin typeface="+mj-ea"/>
            <a:ea typeface="+mj-ea"/>
          </a:endParaRPr>
        </a:p>
      </dsp:txBody>
      <dsp:txXfrm>
        <a:off x="937482" y="1715427"/>
        <a:ext cx="1576798" cy="144539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46887B-6B9D-48C2-9707-1CC601AFB4B1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0703A9-D83A-4EC9-9CB6-7BDB70FDB28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07794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840094-F281-B452-F9B5-886CD0536C9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BA07A14A-99C6-F08D-7765-F4D2EE1394C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A4B9FFCF-64F1-30AC-55DE-FBB19B80F08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FIGURE S2. Among the 122 patients in whom, in addition to serum AMH levels, AFC was evaluated in detail rather than only whether it was ≥10, 30 patients showed no endocrinological abnormalities according to the JSOG 2024 criteria. Among these patients, 21 patients were diagnosed with PCOS according to the Rotterdam/IEBG 2023 criteria applying elevated serum AMH (level 2), defined as an AMH level above the cut-off value level 2 with a specificity of ≥95% (Table 1)</a:t>
            </a:r>
            <a:r>
              <a:rPr kumimoji="1" lang="en-US" altLang="ja-JP" sz="1200" kern="1200" baseline="30000" dirty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26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kern="1200" dirty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(a). Similarly, among the 30 patients without endocrinological abnormalities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sed on</a:t>
            </a:r>
            <a:r>
              <a:rPr lang="ja-JP" altLang="ja-JP">
                <a:effectLst/>
              </a:rPr>
              <a:t> </a:t>
            </a:r>
            <a:r>
              <a:rPr kumimoji="1" lang="en-US" altLang="ja-JP" sz="1200" kern="1200" dirty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the JSOG 2024 criteria, 21 patients were diagnosed with PCOS according to the Rotterdam/IEBG 2023 criteria applying AFC (level 2), defined as an AFC of ≥20 with a specificity of ≥95% (b). The same number of patients were diagnosed with PCOS according to the Rotterdam/IEBG 2023 criteria when applying serum AMH (level 2) and AFC (level 2) (c).</a:t>
            </a:r>
            <a:endParaRPr kumimoji="1" lang="ja-JP" altLang="ja-JP" sz="1200" kern="1200">
              <a:solidFill>
                <a:srgbClr val="FF0000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B99D4FD-A0DA-63CC-69C9-8806BA1D58C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0703A9-D83A-4EC9-9CB6-7BDB70FDB286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461330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477787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1248" y="457200"/>
            <a:ext cx="3931920" cy="1600200"/>
          </a:xfrm>
        </p:spPr>
        <p:txBody>
          <a:bodyPr anchor="b">
            <a:normAutofit/>
          </a:bodyPr>
          <a:lstStyle>
            <a:lvl1pPr>
              <a:defRPr sz="32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1600" y="990600"/>
            <a:ext cx="6172200" cy="4876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1248" y="2057400"/>
            <a:ext cx="3931920" cy="3810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61395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8056034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0362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0362"/>
            <a:ext cx="7734300" cy="581183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07116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4530"/>
            <a:ext cx="9144000" cy="2387600"/>
          </a:xfrm>
        </p:spPr>
        <p:txBody>
          <a:bodyPr anchor="b">
            <a:normAutofit/>
          </a:bodyPr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 algn="ctr">
              <a:buNone/>
              <a:defRPr sz="28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82972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17021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12423"/>
            <a:ext cx="10515600" cy="2851208"/>
          </a:xfrm>
        </p:spPr>
        <p:txBody>
          <a:bodyPr anchor="b">
            <a:normAutofit/>
          </a:bodyPr>
          <a:lstStyle>
            <a:lvl1pPr>
              <a:defRPr sz="60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52633"/>
            <a:ext cx="105156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25890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5127" y="1828800"/>
            <a:ext cx="51816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8800"/>
            <a:ext cx="51816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67766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5127" y="1681850"/>
            <a:ext cx="5156200" cy="825699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5127" y="2507550"/>
            <a:ext cx="5156200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851"/>
            <a:ext cx="5181601" cy="825698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7550"/>
            <a:ext cx="5181601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4069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03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47667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1248" y="457200"/>
            <a:ext cx="3931920" cy="1600197"/>
          </a:xfrm>
        </p:spPr>
        <p:txBody>
          <a:bodyPr anchor="b">
            <a:normAutofit/>
          </a:bodyPr>
          <a:lstStyle>
            <a:lvl1pPr>
              <a:defRPr sz="32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1600" y="990600"/>
            <a:ext cx="6172200" cy="48768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1248" y="2057399"/>
            <a:ext cx="3931920" cy="3810001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14897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9.xml"/><Relationship Id="rId3" Type="http://schemas.openxmlformats.org/officeDocument/2006/relationships/slideLayout" Target="../slideLayouts/slideLayout4.xml"/><Relationship Id="rId7" Type="http://schemas.openxmlformats.org/officeDocument/2006/relationships/slideLayout" Target="../slideLayouts/slideLayout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2.xml"/><Relationship Id="rId5" Type="http://schemas.openxmlformats.org/officeDocument/2006/relationships/slideLayout" Target="../slideLayouts/slideLayout6.xml"/><Relationship Id="rId10" Type="http://schemas.openxmlformats.org/officeDocument/2006/relationships/slideLayout" Target="../slideLayouts/slideLayout11.xml"/><Relationship Id="rId4" Type="http://schemas.openxmlformats.org/officeDocument/2006/relationships/slideLayout" Target="../slideLayouts/slideLayout5.xml"/><Relationship Id="rId9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>
            <a:extLst>
              <a:ext uri="{FF2B5EF4-FFF2-40B4-BE49-F238E27FC236}">
                <a16:creationId xmlns:a16="http://schemas.microsoft.com/office/drawing/2014/main" id="{E4DF6985-E8AA-8D82-B9C0-B26E48C9300E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>
            <a:extLst>
              <a:ext uri="{FF2B5EF4-FFF2-40B4-BE49-F238E27FC236}">
                <a16:creationId xmlns:a16="http://schemas.microsoft.com/office/drawing/2014/main" id="{E3B9B877-3000-7526-45EE-57AFC8584675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2DB030AE-CF29-4083-AF80-B7889CB4D6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charset="0"/>
                <a:ea typeface="ＭＳ Ｐゴシック" charset="-128"/>
              </a:defRPr>
            </a:lvl1pPr>
          </a:lstStyle>
          <a:p>
            <a:pPr>
              <a:defRPr/>
            </a:pPr>
            <a:fld id="{8E6086EF-5FE4-ED44-A28E-F96020E25CF2}" type="datetime1">
              <a:rPr lang="ja-JP" altLang="en-US"/>
              <a:pPr>
                <a:defRPr/>
              </a:pPr>
              <a:t>2026/3/29</a:t>
            </a:fld>
            <a:endParaRPr lang="ja-JP" altLang="en-US" dirty="0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11EE3B35-C440-4116-86F9-625B571910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 dirty="0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54444891-613A-4963-BCA6-E1DF10B093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55D9EB97-9697-5442-AA1C-492F847031E0}" type="slidenum">
              <a:rPr lang="ja-JP" altLang="en-US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14232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5127" y="365760"/>
            <a:ext cx="10515600" cy="13255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5127" y="1828800"/>
            <a:ext cx="10515600" cy="43513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7527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68997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0" r:id="rId1"/>
    <p:sldLayoutId id="2147483691" r:id="rId2"/>
    <p:sldLayoutId id="2147483692" r:id="rId3"/>
    <p:sldLayoutId id="2147483693" r:id="rId4"/>
    <p:sldLayoutId id="2147483694" r:id="rId5"/>
    <p:sldLayoutId id="2147483695" r:id="rId6"/>
    <p:sldLayoutId id="2147483696" r:id="rId7"/>
    <p:sldLayoutId id="2147483697" r:id="rId8"/>
    <p:sldLayoutId id="2147483698" r:id="rId9"/>
    <p:sldLayoutId id="2147483699" r:id="rId10"/>
    <p:sldLayoutId id="2147483700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Wingdings 2" pitchFamily="18" charset="2"/>
        <a:buChar char="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 2" pitchFamily="18" charset="2"/>
        <a:buChar char="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 2" pitchFamily="18" charset="2"/>
        <a:buChar char="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Data" Target="../diagrams/data2.xml"/><Relationship Id="rId13" Type="http://schemas.openxmlformats.org/officeDocument/2006/relationships/diagramData" Target="../diagrams/data3.xml"/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12" Type="http://schemas.microsoft.com/office/2007/relationships/diagramDrawing" Target="../diagrams/drawing2.xml"/><Relationship Id="rId17" Type="http://schemas.microsoft.com/office/2007/relationships/diagramDrawing" Target="../diagrams/drawing3.xml"/><Relationship Id="rId2" Type="http://schemas.openxmlformats.org/officeDocument/2006/relationships/notesSlide" Target="../notesSlides/notesSlide1.xml"/><Relationship Id="rId16" Type="http://schemas.openxmlformats.org/officeDocument/2006/relationships/diagramColors" Target="../diagrams/colors3.xml"/><Relationship Id="rId1" Type="http://schemas.openxmlformats.org/officeDocument/2006/relationships/slideLayout" Target="../slideLayouts/slideLayout1.xml"/><Relationship Id="rId6" Type="http://schemas.openxmlformats.org/officeDocument/2006/relationships/diagramColors" Target="../diagrams/colors1.xml"/><Relationship Id="rId11" Type="http://schemas.openxmlformats.org/officeDocument/2006/relationships/diagramColors" Target="../diagrams/colors2.xml"/><Relationship Id="rId5" Type="http://schemas.openxmlformats.org/officeDocument/2006/relationships/diagramQuickStyle" Target="../diagrams/quickStyle1.xml"/><Relationship Id="rId15" Type="http://schemas.openxmlformats.org/officeDocument/2006/relationships/diagramQuickStyle" Target="../diagrams/quickStyle3.xml"/><Relationship Id="rId10" Type="http://schemas.openxmlformats.org/officeDocument/2006/relationships/diagramQuickStyle" Target="../diagrams/quickStyle2.xml"/><Relationship Id="rId4" Type="http://schemas.openxmlformats.org/officeDocument/2006/relationships/diagramLayout" Target="../diagrams/layout1.xml"/><Relationship Id="rId9" Type="http://schemas.openxmlformats.org/officeDocument/2006/relationships/diagramLayout" Target="../diagrams/layout2.xml"/><Relationship Id="rId14" Type="http://schemas.openxmlformats.org/officeDocument/2006/relationships/diagramLayout" Target="../diagrams/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3E0912-CE8F-2FC8-018C-FF15913B38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79F8D2D-B688-7D15-6864-EEE00D63537A}"/>
              </a:ext>
            </a:extLst>
          </p:cNvPr>
          <p:cNvSpPr txBox="1"/>
          <p:nvPr/>
        </p:nvSpPr>
        <p:spPr>
          <a:xfrm>
            <a:off x="-33127" y="-30152"/>
            <a:ext cx="14127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(a) </a:t>
            </a:r>
            <a:endParaRPr kumimoji="1" lang="ja-JP" altLang="en-US" sz="2400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1BD0C1D-B350-4ECC-2E1F-2B2E2242AD44}"/>
              </a:ext>
            </a:extLst>
          </p:cNvPr>
          <p:cNvSpPr txBox="1"/>
          <p:nvPr/>
        </p:nvSpPr>
        <p:spPr>
          <a:xfrm>
            <a:off x="3540335" y="-30152"/>
            <a:ext cx="14127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(b) </a:t>
            </a:r>
            <a:endParaRPr kumimoji="1" lang="ja-JP" altLang="en-US" sz="2400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595464E3-00E7-2F11-4B5B-59A13ADA8BA6}"/>
              </a:ext>
            </a:extLst>
          </p:cNvPr>
          <p:cNvSpPr txBox="1"/>
          <p:nvPr/>
        </p:nvSpPr>
        <p:spPr>
          <a:xfrm>
            <a:off x="7086279" y="-30152"/>
            <a:ext cx="14127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(c) </a:t>
            </a:r>
            <a:endParaRPr kumimoji="1" lang="ja-JP" altLang="en-US" sz="2400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graphicFrame>
        <p:nvGraphicFramePr>
          <p:cNvPr id="86" name="図表 85">
            <a:extLst>
              <a:ext uri="{FF2B5EF4-FFF2-40B4-BE49-F238E27FC236}">
                <a16:creationId xmlns:a16="http://schemas.microsoft.com/office/drawing/2014/main" id="{96FBAFBA-3C5A-DFCB-711C-245C380874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4530"/>
              </p:ext>
            </p:extLst>
          </p:nvPr>
        </p:nvGraphicFramePr>
        <p:xfrm>
          <a:off x="7240119" y="1188767"/>
          <a:ext cx="5053075" cy="403485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DB09EC29-B7CC-9229-7BF9-54E6796DE8EC}"/>
              </a:ext>
            </a:extLst>
          </p:cNvPr>
          <p:cNvSpPr txBox="1"/>
          <p:nvPr/>
        </p:nvSpPr>
        <p:spPr>
          <a:xfrm>
            <a:off x="8911473" y="1565067"/>
            <a:ext cx="1475125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.7%    </a:t>
            </a:r>
          </a:p>
          <a:p>
            <a:pPr algn="ctr"/>
            <a:r>
              <a:rPr lang="en-US" altLang="ja-JP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2)</a:t>
            </a:r>
            <a:endParaRPr lang="ja-JP" altLang="en-US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29DC513-3D78-2728-B489-920C25629AC9}"/>
              </a:ext>
            </a:extLst>
          </p:cNvPr>
          <p:cNvSpPr txBox="1"/>
          <p:nvPr/>
        </p:nvSpPr>
        <p:spPr>
          <a:xfrm>
            <a:off x="8911473" y="2906515"/>
            <a:ext cx="14751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8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57.1%</a:t>
            </a:r>
          </a:p>
          <a:p>
            <a:pPr algn="ctr"/>
            <a:r>
              <a:rPr lang="en-US" altLang="ja-JP" sz="2000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68) </a:t>
            </a:r>
            <a:endParaRPr lang="ja-JP" altLang="en-US" sz="2000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0653113-2C56-5439-9EC3-317ACFFDC34B}"/>
              </a:ext>
            </a:extLst>
          </p:cNvPr>
          <p:cNvSpPr txBox="1"/>
          <p:nvPr/>
        </p:nvSpPr>
        <p:spPr>
          <a:xfrm>
            <a:off x="8911473" y="4043711"/>
            <a:ext cx="1475125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2.6%</a:t>
            </a:r>
          </a:p>
          <a:p>
            <a:pPr algn="ctr"/>
            <a:r>
              <a:rPr lang="en-US" altLang="ja-JP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15)</a:t>
            </a:r>
            <a:endParaRPr lang="ja-JP" altLang="en-US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5E37C41-A09F-9038-4F4B-964484C30661}"/>
              </a:ext>
            </a:extLst>
          </p:cNvPr>
          <p:cNvSpPr txBox="1"/>
          <p:nvPr/>
        </p:nvSpPr>
        <p:spPr>
          <a:xfrm>
            <a:off x="7714337" y="3612721"/>
            <a:ext cx="1475125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5.0%</a:t>
            </a:r>
          </a:p>
          <a:p>
            <a:pPr algn="ctr"/>
            <a:r>
              <a:rPr lang="en-US" altLang="ja-JP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6)</a:t>
            </a:r>
            <a:endParaRPr lang="ja-JP" altLang="en-US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AE0E90D-7A77-8119-233B-8BDDB00E20BE}"/>
              </a:ext>
            </a:extLst>
          </p:cNvPr>
          <p:cNvSpPr txBox="1"/>
          <p:nvPr/>
        </p:nvSpPr>
        <p:spPr>
          <a:xfrm>
            <a:off x="7408180" y="1490736"/>
            <a:ext cx="1475125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9%</a:t>
            </a:r>
          </a:p>
          <a:p>
            <a:pPr algn="ctr"/>
            <a:r>
              <a:rPr lang="en-US" altLang="ja-JP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7)</a:t>
            </a:r>
            <a:endParaRPr lang="ja-JP" altLang="en-US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70801A7-A2FA-E79F-5A07-2BE277163631}"/>
              </a:ext>
            </a:extLst>
          </p:cNvPr>
          <p:cNvSpPr txBox="1"/>
          <p:nvPr/>
        </p:nvSpPr>
        <p:spPr>
          <a:xfrm>
            <a:off x="10440650" y="1490736"/>
            <a:ext cx="1475125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.6%</a:t>
            </a:r>
          </a:p>
          <a:p>
            <a:pPr algn="ctr"/>
            <a:r>
              <a:rPr lang="en-US" altLang="ja-JP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5)</a:t>
            </a:r>
            <a:endParaRPr lang="ja-JP" altLang="en-US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62F4F47-00BB-06D2-C4AF-2361521A6CB6}"/>
              </a:ext>
            </a:extLst>
          </p:cNvPr>
          <p:cNvSpPr txBox="1"/>
          <p:nvPr/>
        </p:nvSpPr>
        <p:spPr>
          <a:xfrm>
            <a:off x="10249643" y="3612721"/>
            <a:ext cx="1475125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5.0%</a:t>
            </a:r>
          </a:p>
          <a:p>
            <a:pPr algn="ctr"/>
            <a:r>
              <a:rPr lang="en-US" altLang="ja-JP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6)</a:t>
            </a:r>
            <a:endParaRPr lang="ja-JP" altLang="en-US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図表 12">
            <a:extLst>
              <a:ext uri="{FF2B5EF4-FFF2-40B4-BE49-F238E27FC236}">
                <a16:creationId xmlns:a16="http://schemas.microsoft.com/office/drawing/2014/main" id="{CC0FF5A5-7004-E657-B2D9-927F46F99E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0720274"/>
              </p:ext>
            </p:extLst>
          </p:nvPr>
        </p:nvGraphicFramePr>
        <p:xfrm>
          <a:off x="2924533" y="1188767"/>
          <a:ext cx="5053075" cy="403485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8" r:lo="rId9" r:qs="rId10" r:cs="rId11"/>
          </a:graphicData>
        </a:graphic>
      </p:graphicFrame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E3DF5FE-AEC5-3AF9-8103-D96B99A91CA6}"/>
              </a:ext>
            </a:extLst>
          </p:cNvPr>
          <p:cNvSpPr txBox="1"/>
          <p:nvPr/>
        </p:nvSpPr>
        <p:spPr>
          <a:xfrm>
            <a:off x="4215596" y="1726140"/>
            <a:ext cx="1475125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8.0%    </a:t>
            </a:r>
          </a:p>
          <a:p>
            <a:pPr algn="ctr"/>
            <a:r>
              <a:rPr lang="en-US" altLang="ja-JP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9)</a:t>
            </a:r>
            <a:endParaRPr lang="ja-JP" altLang="en-US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B2BEF34-44E6-4456-3E23-C6050B5598DC}"/>
              </a:ext>
            </a:extLst>
          </p:cNvPr>
          <p:cNvSpPr txBox="1"/>
          <p:nvPr/>
        </p:nvSpPr>
        <p:spPr>
          <a:xfrm>
            <a:off x="4793037" y="2860349"/>
            <a:ext cx="14751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8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73.5%</a:t>
            </a:r>
          </a:p>
          <a:p>
            <a:pPr algn="ctr"/>
            <a:r>
              <a:rPr lang="en-US" altLang="ja-JP" sz="2000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83) </a:t>
            </a:r>
            <a:endParaRPr lang="ja-JP" altLang="en-US" sz="2000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2968F5E-6B41-0BE0-9ADC-C134AEBC4675}"/>
              </a:ext>
            </a:extLst>
          </p:cNvPr>
          <p:cNvSpPr txBox="1"/>
          <p:nvPr/>
        </p:nvSpPr>
        <p:spPr>
          <a:xfrm>
            <a:off x="5452443" y="3987194"/>
            <a:ext cx="14751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8.6%</a:t>
            </a:r>
          </a:p>
          <a:p>
            <a:pPr algn="ctr"/>
            <a:r>
              <a:rPr lang="en-US" altLang="ja-JP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21)</a:t>
            </a:r>
            <a:endParaRPr lang="ja-JP" altLang="en-US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8" name="図表 27">
            <a:extLst>
              <a:ext uri="{FF2B5EF4-FFF2-40B4-BE49-F238E27FC236}">
                <a16:creationId xmlns:a16="http://schemas.microsoft.com/office/drawing/2014/main" id="{26EDBCEC-10F7-AADE-DBE7-7D42403B7C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973541"/>
              </p:ext>
            </p:extLst>
          </p:nvPr>
        </p:nvGraphicFramePr>
        <p:xfrm>
          <a:off x="-626052" y="1188767"/>
          <a:ext cx="5053075" cy="403485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3" r:lo="rId14" r:qs="rId15" r:cs="rId16"/>
          </a:graphicData>
        </a:graphic>
      </p:graphicFrame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D8C6C3F-09B5-B7BC-016B-BC8DD66A3396}"/>
              </a:ext>
            </a:extLst>
          </p:cNvPr>
          <p:cNvSpPr txBox="1"/>
          <p:nvPr/>
        </p:nvSpPr>
        <p:spPr>
          <a:xfrm>
            <a:off x="-97964" y="570230"/>
            <a:ext cx="3753253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lang="en-US" altLang="ja-JP" sz="2000" b="1" kern="0" dirty="0">
                <a:solidFill>
                  <a:srgbClr val="2E75B5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Endocrinological abnormalities </a:t>
            </a:r>
          </a:p>
          <a:p>
            <a:pPr lvl="0" algn="ctr">
              <a:defRPr/>
            </a:pPr>
            <a:r>
              <a:rPr lang="en-US" altLang="ja-JP" sz="2000" b="1" kern="0" dirty="0">
                <a:solidFill>
                  <a:srgbClr val="2E75B5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based on JSOG 2024 criteria</a:t>
            </a:r>
          </a:p>
          <a:p>
            <a:pPr algn="ctr"/>
            <a:r>
              <a:rPr kumimoji="1"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2)</a:t>
            </a:r>
            <a:endParaRPr kumimoji="1" lang="ja-JP" altLang="en-US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459E3DE-D2EC-EF2E-DB02-CCC0E3608360}"/>
              </a:ext>
            </a:extLst>
          </p:cNvPr>
          <p:cNvSpPr txBox="1"/>
          <p:nvPr/>
        </p:nvSpPr>
        <p:spPr>
          <a:xfrm>
            <a:off x="890990" y="2875738"/>
            <a:ext cx="14751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8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66.4%</a:t>
            </a:r>
          </a:p>
          <a:p>
            <a:pPr algn="ctr"/>
            <a:r>
              <a:rPr lang="en-US" altLang="ja-JP" sz="2000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75) </a:t>
            </a:r>
            <a:endParaRPr lang="ja-JP" altLang="en-US" sz="2000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1C19A0E-4239-1110-52DE-600F51A195F3}"/>
              </a:ext>
            </a:extLst>
          </p:cNvPr>
          <p:cNvSpPr txBox="1"/>
          <p:nvPr/>
        </p:nvSpPr>
        <p:spPr>
          <a:xfrm>
            <a:off x="328722" y="3987194"/>
            <a:ext cx="14751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8.6%</a:t>
            </a:r>
          </a:p>
          <a:p>
            <a:pPr algn="ctr"/>
            <a:r>
              <a:rPr lang="en-US" altLang="ja-JP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21)</a:t>
            </a:r>
            <a:endParaRPr lang="ja-JP" altLang="en-US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708C67B-B64B-A415-4D6F-EEF7421A91FE}"/>
              </a:ext>
            </a:extLst>
          </p:cNvPr>
          <p:cNvSpPr txBox="1"/>
          <p:nvPr/>
        </p:nvSpPr>
        <p:spPr>
          <a:xfrm>
            <a:off x="1485284" y="1726140"/>
            <a:ext cx="1475125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5.0%</a:t>
            </a:r>
          </a:p>
          <a:p>
            <a:pPr algn="ctr"/>
            <a:r>
              <a:rPr lang="en-US" altLang="ja-JP" kern="100" dirty="0">
                <a:effectLst>
                  <a:glow rad="101600">
                    <a:schemeClr val="bg1">
                      <a:alpha val="60000"/>
                    </a:schemeClr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n=17)</a:t>
            </a:r>
            <a:endParaRPr lang="ja-JP" altLang="en-US" kern="100" dirty="0">
              <a:effectLst>
                <a:glow rad="101600">
                  <a:schemeClr val="bg1">
                    <a:alpha val="60000"/>
                  </a:schemeClr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AB4C755-5C9D-44B3-B513-9CD277DD5F8A}"/>
              </a:ext>
            </a:extLst>
          </p:cNvPr>
          <p:cNvSpPr txBox="1"/>
          <p:nvPr/>
        </p:nvSpPr>
        <p:spPr>
          <a:xfrm>
            <a:off x="-50884" y="4917826"/>
            <a:ext cx="270299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2000" b="1" kern="0" dirty="0">
                <a:solidFill>
                  <a:srgbClr val="FF5600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Elevated serum AMH</a:t>
            </a:r>
          </a:p>
          <a:p>
            <a:pPr algn="ctr">
              <a:defRPr/>
            </a:pPr>
            <a:r>
              <a:rPr lang="en-US" altLang="ja-JP" sz="2000" b="1" kern="0" dirty="0">
                <a:solidFill>
                  <a:srgbClr val="FF5600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(level 2) based on </a:t>
            </a:r>
          </a:p>
          <a:p>
            <a:pPr algn="ctr"/>
            <a:r>
              <a:rPr lang="en-US" altLang="ja-JP" sz="2000" b="1" kern="0" dirty="0">
                <a:solidFill>
                  <a:srgbClr val="FF5600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Rotterdam/IEBG 2023 criteria</a:t>
            </a:r>
          </a:p>
          <a:p>
            <a:pPr algn="ctr"/>
            <a:r>
              <a:rPr lang="en-US" altLang="ja-JP" b="1" kern="0" dirty="0">
                <a:solidFill>
                  <a:srgbClr val="FF5600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96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E675C56-D067-296A-0802-69CA6AC6B80F}"/>
              </a:ext>
            </a:extLst>
          </p:cNvPr>
          <p:cNvSpPr txBox="1"/>
          <p:nvPr/>
        </p:nvSpPr>
        <p:spPr>
          <a:xfrm>
            <a:off x="4274849" y="4917826"/>
            <a:ext cx="264578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" altLang="ja-JP" sz="2000" b="1" dirty="0">
                <a:solidFill>
                  <a:schemeClr val="accent3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C (level 2)</a:t>
            </a:r>
          </a:p>
          <a:p>
            <a:pPr algn="ctr"/>
            <a:r>
              <a:rPr kumimoji="1" lang="en" altLang="ja-JP" sz="2000" b="1" dirty="0">
                <a:solidFill>
                  <a:schemeClr val="accent3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d on </a:t>
            </a:r>
          </a:p>
          <a:p>
            <a:pPr algn="ctr"/>
            <a:r>
              <a:rPr kumimoji="1" lang="en" altLang="ja-JP" sz="2000" b="1" dirty="0">
                <a:solidFill>
                  <a:schemeClr val="accent3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tterdam/IEBG 2023 criteria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04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D668B66-A994-4EB8-DF32-63C6D7065983}"/>
              </a:ext>
            </a:extLst>
          </p:cNvPr>
          <p:cNvSpPr txBox="1"/>
          <p:nvPr/>
        </p:nvSpPr>
        <p:spPr>
          <a:xfrm>
            <a:off x="3815294" y="4252866"/>
            <a:ext cx="792000" cy="646331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non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9</a:t>
            </a: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220729D6-30F8-C9C3-2300-5DF06BED92CF}"/>
              </a:ext>
            </a:extLst>
          </p:cNvPr>
          <p:cNvSpPr txBox="1"/>
          <p:nvPr/>
        </p:nvSpPr>
        <p:spPr>
          <a:xfrm>
            <a:off x="7258871" y="4252866"/>
            <a:ext cx="792000" cy="646331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non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3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0BF6F67-0C3A-8C89-50B6-C4D49BEBBF81}"/>
              </a:ext>
            </a:extLst>
          </p:cNvPr>
          <p:cNvSpPr txBox="1"/>
          <p:nvPr/>
        </p:nvSpPr>
        <p:spPr>
          <a:xfrm>
            <a:off x="3476045" y="570230"/>
            <a:ext cx="3753253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lang="en-US" altLang="ja-JP" sz="2000" b="1" kern="0" dirty="0">
                <a:solidFill>
                  <a:srgbClr val="2E75B5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Endocrinological abnormalities </a:t>
            </a:r>
          </a:p>
          <a:p>
            <a:pPr lvl="0" algn="ctr">
              <a:defRPr/>
            </a:pPr>
            <a:r>
              <a:rPr lang="en-US" altLang="ja-JP" sz="2000" b="1" kern="0" dirty="0">
                <a:solidFill>
                  <a:srgbClr val="2E75B5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based on JSOG 2024 criteria</a:t>
            </a:r>
          </a:p>
          <a:p>
            <a:pPr algn="ctr"/>
            <a:r>
              <a:rPr kumimoji="1"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2)</a:t>
            </a:r>
            <a:endParaRPr kumimoji="1" lang="ja-JP" altLang="en-US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E06E53B-4073-6C17-2732-4728C815C987}"/>
              </a:ext>
            </a:extLst>
          </p:cNvPr>
          <p:cNvSpPr txBox="1"/>
          <p:nvPr/>
        </p:nvSpPr>
        <p:spPr>
          <a:xfrm>
            <a:off x="7785103" y="570230"/>
            <a:ext cx="3753253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lang="en-US" altLang="ja-JP" sz="2000" b="1" kern="0" dirty="0">
                <a:solidFill>
                  <a:srgbClr val="2E75B5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Endocrinological abnormalities </a:t>
            </a:r>
          </a:p>
          <a:p>
            <a:pPr lvl="0" algn="ctr">
              <a:defRPr/>
            </a:pPr>
            <a:r>
              <a:rPr lang="en-US" altLang="ja-JP" sz="2000" b="1" kern="0" dirty="0">
                <a:solidFill>
                  <a:srgbClr val="2E75B5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based on JSOG 2024 criteria</a:t>
            </a:r>
          </a:p>
          <a:p>
            <a:pPr algn="ctr"/>
            <a:r>
              <a:rPr kumimoji="1"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2)</a:t>
            </a:r>
            <a:endParaRPr kumimoji="1" lang="ja-JP" altLang="en-US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4768455-D962-6F8B-5267-EB2BD5F9EBB8}"/>
              </a:ext>
            </a:extLst>
          </p:cNvPr>
          <p:cNvSpPr txBox="1"/>
          <p:nvPr/>
        </p:nvSpPr>
        <p:spPr>
          <a:xfrm>
            <a:off x="7020019" y="4917826"/>
            <a:ext cx="270299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2000" b="1" kern="0" dirty="0">
                <a:solidFill>
                  <a:srgbClr val="FF5600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Elevated serum AMH</a:t>
            </a:r>
          </a:p>
          <a:p>
            <a:pPr algn="ctr">
              <a:defRPr/>
            </a:pPr>
            <a:r>
              <a:rPr lang="en-US" altLang="ja-JP" sz="2000" b="1" kern="0" dirty="0">
                <a:solidFill>
                  <a:srgbClr val="FF5600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(level 2) based on </a:t>
            </a:r>
          </a:p>
          <a:p>
            <a:pPr algn="ctr"/>
            <a:r>
              <a:rPr lang="en-US" altLang="ja-JP" sz="2000" b="1" kern="0" dirty="0">
                <a:solidFill>
                  <a:srgbClr val="FF5600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Rotterdam/IEBG 2023 criteria</a:t>
            </a:r>
          </a:p>
          <a:p>
            <a:pPr algn="ctr"/>
            <a:r>
              <a:rPr lang="en-US" altLang="ja-JP" b="1" kern="0" dirty="0">
                <a:solidFill>
                  <a:srgbClr val="FF5600"/>
                </a:solidFill>
                <a:latin typeface="Times New Roman" panose="02020603050405020304" pitchFamily="18" charset="0"/>
                <a:ea typeface="Century Gothic"/>
                <a:cs typeface="Times New Roman" panose="02020603050405020304" pitchFamily="18" charset="0"/>
                <a:sym typeface="Century Gothic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96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6711A0A-1B35-AC79-BD0F-80C5EBE59CF1}"/>
              </a:ext>
            </a:extLst>
          </p:cNvPr>
          <p:cNvSpPr txBox="1"/>
          <p:nvPr/>
        </p:nvSpPr>
        <p:spPr>
          <a:xfrm>
            <a:off x="9631526" y="4917826"/>
            <a:ext cx="264578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" altLang="ja-JP" sz="2000" b="1" dirty="0">
                <a:solidFill>
                  <a:schemeClr val="accent3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C (level 2)</a:t>
            </a:r>
          </a:p>
          <a:p>
            <a:pPr algn="ctr"/>
            <a:r>
              <a:rPr kumimoji="1" lang="en" altLang="ja-JP" sz="2000" b="1" dirty="0">
                <a:solidFill>
                  <a:schemeClr val="accent3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d on </a:t>
            </a:r>
          </a:p>
          <a:p>
            <a:pPr algn="ctr"/>
            <a:r>
              <a:rPr kumimoji="1" lang="en" altLang="ja-JP" sz="2000" b="1" dirty="0">
                <a:solidFill>
                  <a:schemeClr val="accent3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tterdam/IEBG 2023 criteria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04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FDFEF78-6378-E663-4105-80A8022D7307}"/>
              </a:ext>
            </a:extLst>
          </p:cNvPr>
          <p:cNvSpPr txBox="1"/>
          <p:nvPr/>
        </p:nvSpPr>
        <p:spPr>
          <a:xfrm>
            <a:off x="2552458" y="4252866"/>
            <a:ext cx="792000" cy="646331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non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9</a:t>
            </a: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64AD7C39-D0AB-7E2F-BF90-2C1C05A6989A}"/>
              </a:ext>
            </a:extLst>
          </p:cNvPr>
          <p:cNvCxnSpPr>
            <a:cxnSpLocks/>
          </p:cNvCxnSpPr>
          <p:nvPr/>
        </p:nvCxnSpPr>
        <p:spPr>
          <a:xfrm>
            <a:off x="8192294" y="2175474"/>
            <a:ext cx="471140" cy="432000"/>
          </a:xfrm>
          <a:prstGeom prst="line">
            <a:avLst/>
          </a:prstGeom>
          <a:ln w="158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8547CC97-835C-78F7-9BBF-E0EF1B37DDCB}"/>
              </a:ext>
            </a:extLst>
          </p:cNvPr>
          <p:cNvCxnSpPr>
            <a:cxnSpLocks noChangeAspect="1"/>
          </p:cNvCxnSpPr>
          <p:nvPr/>
        </p:nvCxnSpPr>
        <p:spPr>
          <a:xfrm flipH="1">
            <a:off x="10573115" y="2175474"/>
            <a:ext cx="554823" cy="432000"/>
          </a:xfrm>
          <a:prstGeom prst="line">
            <a:avLst/>
          </a:prstGeom>
          <a:ln w="158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3591062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HDOfficeLightV0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7605</TotalTime>
  <Words>413</Words>
  <Application>Microsoft Macintosh PowerPoint</Application>
  <PresentationFormat>ワイド画面</PresentationFormat>
  <Paragraphs>6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Times New Roman</vt:lpstr>
      <vt:lpstr>Wingdings 2</vt:lpstr>
      <vt:lpstr>1_Office テーマ</vt:lpstr>
      <vt:lpstr>HDOfficeLightV0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野口　拓樹</cp:lastModifiedBy>
  <cp:revision>971</cp:revision>
  <cp:lastPrinted>2022-12-04T21:39:05Z</cp:lastPrinted>
  <dcterms:created xsi:type="dcterms:W3CDTF">2020-09-11T04:04:24Z</dcterms:created>
  <dcterms:modified xsi:type="dcterms:W3CDTF">2026-03-29T09:59:07Z</dcterms:modified>
</cp:coreProperties>
</file>